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2DEBE2-C58F-45CC-857A-2562A135AC2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239594-B2CF-4F68-B328-0FF0D192426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335368-E7A1-4500-9816-1AEAC50F571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4A6060-456B-4D3D-A227-7BCC98C1F1A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15B15F-DCDA-4638-BF38-C180C8F76C6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144BD4-CFEE-4E1A-971B-2B09DBEA20C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6CD9BE-034B-4BF8-9A20-0DC504EA32E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66F2AD-04E5-4181-B5F2-4BC5CBDAD21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E7E413-6F57-48A1-9573-C8A8EA3C46A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E4B9DD-2D23-4A81-BFC3-96B5D55FAE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71E34A-7647-478F-9C51-DB0DF0EF8B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B519E7-85C9-4869-82CD-6FB0D9BAED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1CB3B45-7637-40D2-973D-82992CBB7E23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214200" y="1714680"/>
          <a:ext cx="8535960" cy="2044440"/>
        </p:xfrm>
        <a:graphic>
          <a:graphicData uri="http://schemas.openxmlformats.org/drawingml/2006/table">
            <a:tbl>
              <a:tblPr/>
              <a:tblGrid>
                <a:gridCol w="1143000"/>
                <a:gridCol w="1228680"/>
                <a:gridCol w="657360"/>
                <a:gridCol w="619200"/>
                <a:gridCol w="728640"/>
                <a:gridCol w="803160"/>
                <a:gridCol w="730440"/>
                <a:gridCol w="693720"/>
                <a:gridCol w="691920"/>
                <a:gridCol w="655920"/>
                <a:gridCol w="583920"/>
              </a:tblGrid>
              <a:tr h="404640">
                <a:tc rowSpan="3"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.5L/9.5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im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:00-9: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:00-11: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:00-15: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:00-17: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7:00-19: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9:00-21: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1:00-23: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3:00-5: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:00-7: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445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emperatur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56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ight (LS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63320">
                <a:tc rowSpan="3"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.5L/14.5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im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:20-9: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:00-11: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:00-13: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:00-16: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6:00-17: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7:20-21: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1:00-23: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3:00-5: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:00-7: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876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emperatur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887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Light (LS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Text Box 98"/>
          <p:cNvSpPr/>
          <p:nvPr/>
        </p:nvSpPr>
        <p:spPr>
          <a:xfrm>
            <a:off x="179280" y="1222200"/>
            <a:ext cx="821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343080" indent="-343080"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 Table  1  The diurnal variation of light, temperature in the illumination incubato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3" name=""/>
          <p:cNvGraphicFramePr/>
          <p:nvPr/>
        </p:nvGraphicFramePr>
        <p:xfrm>
          <a:off x="774720" y="1714680"/>
          <a:ext cx="7726320" cy="3001680"/>
        </p:xfrm>
        <a:graphic>
          <a:graphicData uri="http://schemas.openxmlformats.org/drawingml/2006/table">
            <a:tbl>
              <a:tblPr/>
              <a:tblGrid>
                <a:gridCol w="1857240"/>
                <a:gridCol w="1511280"/>
                <a:gridCol w="857520"/>
                <a:gridCol w="928440"/>
                <a:gridCol w="928800"/>
                <a:gridCol w="785880"/>
                <a:gridCol w="857160"/>
              </a:tblGrid>
              <a:tr h="301320"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ros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</a:t>
                      </a:r>
                      <a:r>
                        <a:rPr b="1" lang="zh-CN" sz="12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 </a:t>
                      </a: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henotyp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3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</a:t>
                      </a:r>
                      <a:r>
                        <a:rPr b="1" lang="zh-CN" sz="12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popul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χ</a:t>
                      </a:r>
                      <a:r>
                        <a:rPr b="1" lang="zh-CN" sz="12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(3:1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 valu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838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ota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Wild typ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utant typ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733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hd10</a:t>
                      </a: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/NIP 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Wild typ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0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ts val="22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357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ts val="22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549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733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hd10</a:t>
                      </a: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/WYJ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Wild typ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7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8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ts val="22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552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ts val="22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457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733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hd10</a:t>
                      </a: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/CJ0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Wild typ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ts val="22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279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ts val="22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597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733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IP/</a:t>
                      </a:r>
                      <a:r>
                        <a:rPr b="1" i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hd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Wild typ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ts val="22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230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ts val="22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63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733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WYJ7/ </a:t>
                      </a:r>
                      <a:r>
                        <a:rPr b="1" i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hd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Wild typ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4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8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ts val="22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2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ts val="22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603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733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J06/ </a:t>
                      </a:r>
                      <a:r>
                        <a:rPr b="1" i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hd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Wild typ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ts val="22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549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ts val="22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458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4" name="矩形 5"/>
          <p:cNvSpPr/>
          <p:nvPr/>
        </p:nvSpPr>
        <p:spPr>
          <a:xfrm>
            <a:off x="642960" y="1071720"/>
            <a:ext cx="5857920" cy="37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ts val="22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Table 2 Genetic analysis of </a:t>
            </a:r>
            <a:r>
              <a:rPr b="1" i="1" lang="zh-CN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hd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5" name=""/>
          <p:cNvGraphicFramePr/>
          <p:nvPr/>
        </p:nvGraphicFramePr>
        <p:xfrm>
          <a:off x="428760" y="1357200"/>
          <a:ext cx="8186760" cy="4537080"/>
        </p:xfrm>
        <a:graphic>
          <a:graphicData uri="http://schemas.openxmlformats.org/drawingml/2006/table">
            <a:tbl>
              <a:tblPr/>
              <a:tblGrid>
                <a:gridCol w="757080"/>
                <a:gridCol w="2643120"/>
                <a:gridCol w="2928960"/>
                <a:gridCol w="928800"/>
                <a:gridCol w="928800"/>
              </a:tblGrid>
              <a:tr h="45900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rke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orward primer sequences(5’-3’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everse primer sequences(5’-3’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oduct siz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t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003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M568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CACATGGTGAGACGTCCT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AGTCCTGTAGTAGGTCACACC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ppin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427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K10-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CACCATTGTCGTGCTC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TCCGGTCATCCCTCTT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ppin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715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K10-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GTGGTCGGTAATCAGCACT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AATGGTTAAGTCATCAGTGC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ppin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697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K10-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GGAAATTGCGTCCTC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AAGCGATGGGTGGTG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9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ppin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715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K10-1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AACAACTGTAGGCAAC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CTAAACTTCTGAGCGA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ppin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700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K10-1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ACCACGCTGGGCAAGA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GTAGCCCTCCTCGTCCTC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8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ppin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715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K10-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CGAGATGAAACTAAAGG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ACAGCAGAATTGAGATGAG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8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quencin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711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K10-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CGTATGGTGGTGGGTA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AATCCGTTGTATTAGAGC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9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quencin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700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K10-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CGCCGTTAAACACACACC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TTTCCATCAATGCCTC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9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quencin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715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K10-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CTTTTTCAATGGTTGGGC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CAGGTGGTAGTAGTGA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2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quencin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679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K10-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ATCAATCCACAGTCGTC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GGCATCCAGAGTCGCA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2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quencin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6" name="矩形 7"/>
          <p:cNvSpPr/>
          <p:nvPr/>
        </p:nvSpPr>
        <p:spPr>
          <a:xfrm>
            <a:off x="433080" y="714240"/>
            <a:ext cx="6555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Table 3  Molecular markers used for </a:t>
            </a:r>
            <a:r>
              <a:rPr b="1" i="1" lang="zh-CN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hd10 </a:t>
            </a:r>
            <a:r>
              <a:rPr b="1" lang="zh-CN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apping and sequencin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矩形 5"/>
          <p:cNvSpPr/>
          <p:nvPr/>
        </p:nvSpPr>
        <p:spPr>
          <a:xfrm>
            <a:off x="214200" y="549360"/>
            <a:ext cx="5857920" cy="37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ts val="22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Table 4 Real time-PCR primers used in this stud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8" name=""/>
          <p:cNvGraphicFramePr/>
          <p:nvPr/>
        </p:nvGraphicFramePr>
        <p:xfrm>
          <a:off x="390600" y="1071720"/>
          <a:ext cx="8429400" cy="4700520"/>
        </p:xfrm>
        <a:graphic>
          <a:graphicData uri="http://schemas.openxmlformats.org/drawingml/2006/table">
            <a:tbl>
              <a:tblPr/>
              <a:tblGrid>
                <a:gridCol w="1143000"/>
                <a:gridCol w="2928960"/>
                <a:gridCol w="2928960"/>
                <a:gridCol w="1428480"/>
              </a:tblGrid>
              <a:tr h="42840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ene symbo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orward primer sequences(5’-3’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everse primer sequences(5’-3’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eferanc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1440"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hd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ATCGATTCCAACAACAAGCA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GTCGAGAGCGGTGGATG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85840"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d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GTTTCGCCAAGAGATCA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GATAGAGCTGCAGTGGAGAA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Kojima et al., 200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85840"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FT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GTCCATGGTGACCCAAC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CGGGTCTACCATCACGAG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oi et al., 200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85840"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d3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CTAACGATGATCCCGA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CTGCAATGTATAGCATG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Kojima et al., 200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85480"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MADS1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GGTTGCGAGACGAGGA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AAAGACGGTGCTGGACGA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aoka et al., 2011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85840"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MADS1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GTCGTCGGCCAAACA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GACTTCAATTCATTCAAGGTTGC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aoka et al., 2011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85840"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sGI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TGGATGCGCTTTGTGACA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GCCTGCAGAACGATAGC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Hayama et al., 200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85840"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HD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GGTGCTACGAGAAGCAAATC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GGCCTCATCTCGGCATA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Xue et al., 2008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85480"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HD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GTGCAATGGTTTAGACTAAA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ACAGCATCAGCATCAACA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Yan et al., 20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85840"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hd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GACAATAGCTCGATCGC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AGCCCGAAGCTGACACTG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oi et al., 2004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85840"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zh-CN" sz="1200" spc="-1" strike="noStrike">
                          <a:solidFill>
                            <a:srgbClr val="ff0000"/>
                          </a:solidFill>
                          <a:latin typeface="Times New Roman"/>
                          <a:ea typeface="Times New Roman"/>
                        </a:rPr>
                        <a:t>Dep1 </a:t>
                      </a:r>
                      <a:r>
                        <a:rPr b="0" i="1" lang="zh-CN" sz="18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	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ff0000"/>
                          </a:solidFill>
                          <a:latin typeface="Times New Roman"/>
                          <a:ea typeface="Times New Roman"/>
                        </a:rPr>
                        <a:t>GCGAGATCACGTTCCTCAAG</a:t>
                      </a:r>
                      <a:r>
                        <a:rPr b="1" lang="zh-CN" sz="18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	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ff0000"/>
                          </a:solidFill>
                          <a:latin typeface="Times New Roman"/>
                          <a:ea typeface="Times New Roman"/>
                        </a:rPr>
                        <a:t>TGCAGTTTGGCTTACAGCAT</a:t>
                      </a:r>
                      <a:r>
                        <a:rPr b="1" lang="zh-CN" sz="1200" spc="-1" strike="noStrike">
                          <a:solidFill>
                            <a:srgbClr val="ff0000"/>
                          </a:solidFill>
                          <a:latin typeface="Times New Roman"/>
                          <a:ea typeface="Times New Roman"/>
                        </a:rPr>
                        <a:t>	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ff0000"/>
                          </a:solidFill>
                          <a:latin typeface="Times New Roman"/>
                          <a:ea typeface="Times New Roman"/>
                        </a:rPr>
                        <a:t>Huang et al., 200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85840"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zh-CN" sz="1200" spc="-1" strike="noStrike">
                          <a:solidFill>
                            <a:srgbClr val="ff0000"/>
                          </a:solidFill>
                          <a:latin typeface="Times New Roman"/>
                          <a:ea typeface="Times New Roman"/>
                        </a:rPr>
                        <a:t>FZP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ff0000"/>
                          </a:solidFill>
                          <a:latin typeface="Times New Roman"/>
                          <a:ea typeface="Times New Roman"/>
                        </a:rPr>
                        <a:t>AGATGGTCGCCGGCTTCT</a:t>
                      </a:r>
                      <a:r>
                        <a:rPr b="1" lang="zh-CN" sz="1200" spc="-1" strike="noStrike">
                          <a:solidFill>
                            <a:srgbClr val="ff0000"/>
                          </a:solidFill>
                          <a:latin typeface="Times New Roman"/>
                          <a:ea typeface="Times New Roman"/>
                        </a:rPr>
                        <a:t>	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ff0000"/>
                          </a:solidFill>
                          <a:latin typeface="Times New Roman"/>
                          <a:ea typeface="Times New Roman"/>
                        </a:rPr>
                        <a:t>ATGGAGAGTAGGAGTAGGAG</a:t>
                      </a:r>
                      <a:r>
                        <a:rPr b="1" lang="zh-CN" sz="1200" spc="-1" strike="noStrike">
                          <a:solidFill>
                            <a:srgbClr val="ff0000"/>
                          </a:solidFill>
                          <a:latin typeface="Times New Roman"/>
                          <a:ea typeface="Times New Roman"/>
                        </a:rPr>
                        <a:t>	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ff0000"/>
                          </a:solidFill>
                          <a:latin typeface="Times New Roman"/>
                          <a:ea typeface="Times New Roman"/>
                        </a:rPr>
                        <a:t>Huang et al., 200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85480"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zh-CN" sz="1200" spc="-1" strike="noStrike">
                          <a:solidFill>
                            <a:srgbClr val="ff0000"/>
                          </a:solidFill>
                          <a:latin typeface="Times New Roman"/>
                          <a:ea typeface="Times New Roman"/>
                        </a:rPr>
                        <a:t>LAX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ff0000"/>
                          </a:solidFill>
                          <a:latin typeface="Times New Roman"/>
                          <a:ea typeface="Times New Roman"/>
                        </a:rPr>
                        <a:t>GCCATCCACTACGTCAAGT</a:t>
                      </a:r>
                      <a:r>
                        <a:rPr b="1" lang="zh-CN" sz="1200" spc="-1" strike="noStrike">
                          <a:solidFill>
                            <a:srgbClr val="ff0000"/>
                          </a:solidFill>
                          <a:latin typeface="Times New Roman"/>
                          <a:ea typeface="Times New Roman"/>
                        </a:rPr>
                        <a:t>	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ff0000"/>
                          </a:solidFill>
                          <a:latin typeface="Times New Roman"/>
                          <a:ea typeface="Times New Roman"/>
                        </a:rPr>
                        <a:t>TGGACGAAGACACAGCAAGG</a:t>
                      </a:r>
                      <a:r>
                        <a:rPr b="1" lang="zh-CN" sz="1200" spc="-1" strike="noStrike">
                          <a:solidFill>
                            <a:srgbClr val="ff0000"/>
                          </a:solidFill>
                          <a:latin typeface="Times New Roman"/>
                          <a:ea typeface="Times New Roman"/>
                        </a:rPr>
                        <a:t>	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ff0000"/>
                          </a:solidFill>
                          <a:latin typeface="Times New Roman"/>
                          <a:ea typeface="Times New Roman"/>
                        </a:rPr>
                        <a:t>Huang et al., 200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85840"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zh-CN" sz="1200" spc="-1" strike="noStrike">
                          <a:solidFill>
                            <a:srgbClr val="ff0000"/>
                          </a:solidFill>
                          <a:latin typeface="Times New Roman"/>
                          <a:ea typeface="Times New Roman"/>
                        </a:rPr>
                        <a:t>SP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ff0000"/>
                          </a:solidFill>
                          <a:latin typeface="Times New Roman"/>
                          <a:ea typeface="Times New Roman"/>
                        </a:rPr>
                        <a:t>CGTCTTTGTGCTAGGGATCC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ff0000"/>
                          </a:solidFill>
                          <a:latin typeface="Times New Roman"/>
                          <a:ea typeface="Times New Roman"/>
                        </a:rPr>
                        <a:t>TGACAGCGGGTAGTGCATCT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85840"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UBQ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AGCCTCTGTTCGTCAAGT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TCGATGGTCCATTAAAC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>
                        <a:lnSpc>
                          <a:spcPts val="15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zh-CN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Kojima et al.,200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矩形 3"/>
          <p:cNvSpPr/>
          <p:nvPr/>
        </p:nvSpPr>
        <p:spPr>
          <a:xfrm>
            <a:off x="357120" y="4214880"/>
            <a:ext cx="8501040" cy="105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upplemental  Figure  1 Transcriptional levels in </a:t>
            </a:r>
            <a:r>
              <a:rPr b="1" i="1" lang="zh-CN" sz="14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ghd10 </a:t>
            </a:r>
            <a:r>
              <a:rPr b="1" lang="zh-CN" sz="14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 and WYJ7 of (A) </a:t>
            </a:r>
            <a:r>
              <a:rPr b="1" i="1" lang="zh-CN" sz="14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DEP1</a:t>
            </a:r>
            <a:r>
              <a:rPr b="1" lang="zh-CN" sz="14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, (B) </a:t>
            </a:r>
            <a:r>
              <a:rPr b="1" i="1" lang="zh-CN" sz="14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FZP</a:t>
            </a:r>
            <a:r>
              <a:rPr b="1" lang="zh-CN" sz="14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, (C) </a:t>
            </a:r>
            <a:r>
              <a:rPr b="1" i="1" lang="zh-CN" sz="14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LAX1</a:t>
            </a:r>
            <a:r>
              <a:rPr b="1" lang="zh-CN" sz="14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, (D) </a:t>
            </a:r>
            <a:r>
              <a:rPr b="1" i="1" lang="zh-CN" sz="14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P1</a:t>
            </a:r>
            <a:r>
              <a:rPr b="1" lang="zh-CN" sz="14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. Data are displayed as the ratio of expression to rice </a:t>
            </a:r>
            <a:r>
              <a:rPr b="1" i="1" lang="zh-CN" sz="14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RUBQ2</a:t>
            </a:r>
            <a:r>
              <a:rPr b="1" lang="zh-CN" sz="14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 RNA, data given as mean ± standard error. All assays were repeated at least three times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0" name="组合 26"/>
          <p:cNvGrpSpPr/>
          <p:nvPr/>
        </p:nvGrpSpPr>
        <p:grpSpPr>
          <a:xfrm>
            <a:off x="142560" y="1773360"/>
            <a:ext cx="8787240" cy="1958760"/>
            <a:chOff x="142560" y="1773360"/>
            <a:chExt cx="8787240" cy="1958760"/>
          </a:xfrm>
        </p:grpSpPr>
        <p:grpSp>
          <p:nvGrpSpPr>
            <p:cNvPr id="51" name="组合 14"/>
            <p:cNvGrpSpPr/>
            <p:nvPr/>
          </p:nvGrpSpPr>
          <p:grpSpPr>
            <a:xfrm>
              <a:off x="6692760" y="1915920"/>
              <a:ext cx="2237040" cy="1714320"/>
              <a:chOff x="6692760" y="1915920"/>
              <a:chExt cx="2237040" cy="1714320"/>
            </a:xfrm>
          </p:grpSpPr>
          <p:pic>
            <p:nvPicPr>
              <p:cNvPr id="52" name="Picture 4" descr=""/>
              <p:cNvPicPr/>
              <p:nvPr/>
            </p:nvPicPr>
            <p:blipFill>
              <a:blip r:embed="rId1"/>
              <a:srcRect l="0" t="0" r="16186" b="5236"/>
              <a:stretch/>
            </p:blipFill>
            <p:spPr>
              <a:xfrm>
                <a:off x="7021800" y="1915920"/>
                <a:ext cx="1908000" cy="17143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3" name="TextBox 5"/>
              <p:cNvSpPr/>
              <p:nvPr/>
            </p:nvSpPr>
            <p:spPr>
              <a:xfrm rot="10800000">
                <a:off x="6692760" y="1982520"/>
                <a:ext cx="484920" cy="1357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zh-CN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Relative level of expression of </a:t>
                </a:r>
                <a:r>
                  <a:rPr b="1" i="1" lang="zh-CN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P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4" name="组合 13"/>
            <p:cNvGrpSpPr/>
            <p:nvPr/>
          </p:nvGrpSpPr>
          <p:grpSpPr>
            <a:xfrm>
              <a:off x="2282040" y="1900080"/>
              <a:ext cx="2124000" cy="1724040"/>
              <a:chOff x="2282040" y="1900080"/>
              <a:chExt cx="2124000" cy="1724040"/>
            </a:xfrm>
          </p:grpSpPr>
          <p:sp>
            <p:nvSpPr>
              <p:cNvPr id="55" name="TextBox 5"/>
              <p:cNvSpPr/>
              <p:nvPr/>
            </p:nvSpPr>
            <p:spPr>
              <a:xfrm rot="10800000">
                <a:off x="2282040" y="1971000"/>
                <a:ext cx="484920" cy="1357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zh-CN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Relative level of expression of </a:t>
                </a:r>
                <a:r>
                  <a:rPr b="1" i="1" lang="zh-CN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FZP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56" name="Picture 5" descr=""/>
              <p:cNvPicPr/>
              <p:nvPr/>
            </p:nvPicPr>
            <p:blipFill>
              <a:blip r:embed="rId2"/>
              <a:srcRect l="0" t="0" r="21472" b="6375"/>
              <a:stretch/>
            </p:blipFill>
            <p:spPr>
              <a:xfrm>
                <a:off x="2577600" y="1900080"/>
                <a:ext cx="1828440" cy="1724040"/>
              </a:xfrm>
              <a:prstGeom prst="rect">
                <a:avLst/>
              </a:prstGeom>
              <a:ln w="0">
                <a:noFill/>
              </a:ln>
            </p:spPr>
          </p:pic>
        </p:grpSp>
        <p:grpSp>
          <p:nvGrpSpPr>
            <p:cNvPr id="57" name="组合 16"/>
            <p:cNvGrpSpPr/>
            <p:nvPr/>
          </p:nvGrpSpPr>
          <p:grpSpPr>
            <a:xfrm>
              <a:off x="4487400" y="1886760"/>
              <a:ext cx="2156400" cy="1743840"/>
              <a:chOff x="4487400" y="1886760"/>
              <a:chExt cx="2156400" cy="1743840"/>
            </a:xfrm>
          </p:grpSpPr>
          <p:sp>
            <p:nvSpPr>
              <p:cNvPr id="58" name="TextBox 5"/>
              <p:cNvSpPr/>
              <p:nvPr/>
            </p:nvSpPr>
            <p:spPr>
              <a:xfrm rot="10800000">
                <a:off x="4487400" y="1999440"/>
                <a:ext cx="484920" cy="1357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zh-CN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Relative level of expression of </a:t>
                </a:r>
                <a:r>
                  <a:rPr b="1" i="1" lang="zh-CN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LAX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59" name="Picture 6" descr=""/>
              <p:cNvPicPr/>
              <p:nvPr/>
            </p:nvPicPr>
            <p:blipFill>
              <a:blip r:embed="rId3"/>
              <a:srcRect l="0" t="0" r="21296" b="5319"/>
              <a:stretch/>
            </p:blipFill>
            <p:spPr>
              <a:xfrm>
                <a:off x="4815360" y="1886760"/>
                <a:ext cx="1828440" cy="1743840"/>
              </a:xfrm>
              <a:prstGeom prst="rect">
                <a:avLst/>
              </a:prstGeom>
              <a:ln w="0">
                <a:noFill/>
              </a:ln>
            </p:spPr>
          </p:pic>
        </p:grpSp>
        <p:grpSp>
          <p:nvGrpSpPr>
            <p:cNvPr id="60" name="组合 19"/>
            <p:cNvGrpSpPr/>
            <p:nvPr/>
          </p:nvGrpSpPr>
          <p:grpSpPr>
            <a:xfrm>
              <a:off x="142560" y="1915920"/>
              <a:ext cx="2171880" cy="1816200"/>
              <a:chOff x="142560" y="1915920"/>
              <a:chExt cx="2171880" cy="1816200"/>
            </a:xfrm>
          </p:grpSpPr>
          <p:sp>
            <p:nvSpPr>
              <p:cNvPr id="61" name="TextBox 5"/>
              <p:cNvSpPr/>
              <p:nvPr/>
            </p:nvSpPr>
            <p:spPr>
              <a:xfrm rot="10800000">
                <a:off x="142560" y="1977480"/>
                <a:ext cx="484920" cy="1357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zh-CN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Relative level of expression of </a:t>
                </a:r>
                <a:r>
                  <a:rPr b="1" i="1" lang="zh-CN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DEP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62" name="Picture 7" descr=""/>
              <p:cNvPicPr/>
              <p:nvPr/>
            </p:nvPicPr>
            <p:blipFill>
              <a:blip r:embed="rId4"/>
              <a:stretch/>
            </p:blipFill>
            <p:spPr>
              <a:xfrm>
                <a:off x="448920" y="1915920"/>
                <a:ext cx="1865520" cy="181620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63" name="TextBox 21"/>
            <p:cNvSpPr/>
            <p:nvPr/>
          </p:nvSpPr>
          <p:spPr>
            <a:xfrm>
              <a:off x="180720" y="1773360"/>
              <a:ext cx="428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zh-CN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A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Box 22"/>
            <p:cNvSpPr/>
            <p:nvPr/>
          </p:nvSpPr>
          <p:spPr>
            <a:xfrm>
              <a:off x="2313000" y="1785960"/>
              <a:ext cx="428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zh-CN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B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Box 23"/>
            <p:cNvSpPr/>
            <p:nvPr/>
          </p:nvSpPr>
          <p:spPr>
            <a:xfrm>
              <a:off x="4494240" y="1785960"/>
              <a:ext cx="428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zh-CN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C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TextBox 24"/>
            <p:cNvSpPr/>
            <p:nvPr/>
          </p:nvSpPr>
          <p:spPr>
            <a:xfrm>
              <a:off x="6710400" y="1779480"/>
              <a:ext cx="428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zh-CN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D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8-12T03:54:05Z</dcterms:created>
  <dc:creator>user</dc:creator>
  <dc:description/>
  <dc:language>en-US</dc:language>
  <cp:lastModifiedBy>user</cp:lastModifiedBy>
  <dcterms:modified xsi:type="dcterms:W3CDTF">2013-08-12T03:54:38Z</dcterms:modified>
  <cp:revision>1</cp:revision>
  <dc:subject/>
  <dc:title>幻灯片 1</dc:title>
</cp:coreProperties>
</file>